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7" r:id="rId2"/>
    <p:sldId id="263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2315954-74EC-4BBA-B269-C7936108F6F2}" v="2" dt="2026-03-31T21:59:52.0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35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Wallace" userId="7a92b5d4-21f1-4929-81f4-746d288668f5" providerId="ADAL" clId="{02315954-74EC-4BBA-B269-C7936108F6F2}"/>
    <pc:docChg chg="addSld delSld modSld">
      <pc:chgData name="Nicholas Wallace" userId="7a92b5d4-21f1-4929-81f4-746d288668f5" providerId="ADAL" clId="{02315954-74EC-4BBA-B269-C7936108F6F2}" dt="2026-03-31T22:00:46.332" v="3"/>
      <pc:docMkLst>
        <pc:docMk/>
      </pc:docMkLst>
      <pc:sldChg chg="modSp add mod">
        <pc:chgData name="Nicholas Wallace" userId="7a92b5d4-21f1-4929-81f4-746d288668f5" providerId="ADAL" clId="{02315954-74EC-4BBA-B269-C7936108F6F2}" dt="2026-03-31T22:00:46.332" v="3"/>
        <pc:sldMkLst>
          <pc:docMk/>
          <pc:sldMk cId="1632795120" sldId="263"/>
        </pc:sldMkLst>
        <pc:spChg chg="mod">
          <ac:chgData name="Nicholas Wallace" userId="7a92b5d4-21f1-4929-81f4-746d288668f5" providerId="ADAL" clId="{02315954-74EC-4BBA-B269-C7936108F6F2}" dt="2026-03-31T22:00:46.332" v="3"/>
          <ac:spMkLst>
            <pc:docMk/>
            <pc:sldMk cId="1632795120" sldId="263"/>
            <ac:spMk id="3" creationId="{445869B9-D278-6FEE-AF88-42F4C27CC553}"/>
          </ac:spMkLst>
        </pc:spChg>
      </pc:sldChg>
      <pc:sldChg chg="del">
        <pc:chgData name="Nicholas Wallace" userId="7a92b5d4-21f1-4929-81f4-746d288668f5" providerId="ADAL" clId="{02315954-74EC-4BBA-B269-C7936108F6F2}" dt="2026-03-31T21:51:47.848" v="1" actId="47"/>
        <pc:sldMkLst>
          <pc:docMk/>
          <pc:sldMk cId="3017115828" sldId="276"/>
        </pc:sldMkLst>
      </pc:sldChg>
      <pc:sldChg chg="add">
        <pc:chgData name="Nicholas Wallace" userId="7a92b5d4-21f1-4929-81f4-746d288668f5" providerId="ADAL" clId="{02315954-74EC-4BBA-B269-C7936108F6F2}" dt="2026-03-31T21:51:46.104" v="0"/>
        <pc:sldMkLst>
          <pc:docMk/>
          <pc:sldMk cId="3129776892" sldId="27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8E9699-3A4E-402F-B7EE-D46DA7B4DA7D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49543E-A5E2-4F4A-ACBD-15EE0CD5E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29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54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87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8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10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9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06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375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9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2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05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67359F-9A48-4A05-BE6A-A9FF163E3EA8}" type="datetimeFigureOut">
              <a:rPr lang="en-US" smtClean="0"/>
              <a:t>3/3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98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DE18FE-D15A-80A6-B1D4-1BA05C1AAB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C090BFB8-15CC-0435-5881-67FD3525D0A9}"/>
              </a:ext>
            </a:extLst>
          </p:cNvPr>
          <p:cNvSpPr txBox="1"/>
          <p:nvPr/>
        </p:nvSpPr>
        <p:spPr>
          <a:xfrm>
            <a:off x="22103" y="3222753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39DF0CA-DC59-A6D0-1B0F-BCA77C7D9818}"/>
              </a:ext>
            </a:extLst>
          </p:cNvPr>
          <p:cNvSpPr txBox="1"/>
          <p:nvPr/>
        </p:nvSpPr>
        <p:spPr>
          <a:xfrm>
            <a:off x="28136" y="56585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93DF79D-DE11-2505-F021-D7A3803B1C4B}"/>
              </a:ext>
            </a:extLst>
          </p:cNvPr>
          <p:cNvSpPr txBox="1"/>
          <p:nvPr/>
        </p:nvSpPr>
        <p:spPr>
          <a:xfrm>
            <a:off x="0" y="515851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B0B3FDEC-019D-C7B5-0526-D82FEA1DF69C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858000" cy="74562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6:</a:t>
            </a:r>
          </a:p>
        </p:txBody>
      </p:sp>
      <p:pic>
        <p:nvPicPr>
          <p:cNvPr id="5" name="Picture 4" descr="A collage of cells&#10;&#10;Description automatically generated">
            <a:extLst>
              <a:ext uri="{FF2B5EF4-FFF2-40B4-BE49-F238E27FC236}">
                <a16:creationId xmlns:a16="http://schemas.microsoft.com/office/drawing/2014/main" id="{A9F72462-7881-DEEF-7FE3-9EF198F0E01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487" t="9023" b="50000"/>
          <a:stretch/>
        </p:blipFill>
        <p:spPr>
          <a:xfrm>
            <a:off x="466725" y="1019175"/>
            <a:ext cx="5676900" cy="1242199"/>
          </a:xfrm>
          <a:prstGeom prst="rect">
            <a:avLst/>
          </a:prstGeom>
        </p:spPr>
      </p:pic>
      <p:pic>
        <p:nvPicPr>
          <p:cNvPr id="7" name="Picture 6" descr="A collage of cells&#10;&#10;Description automatically generated">
            <a:extLst>
              <a:ext uri="{FF2B5EF4-FFF2-40B4-BE49-F238E27FC236}">
                <a16:creationId xmlns:a16="http://schemas.microsoft.com/office/drawing/2014/main" id="{A9F72462-7881-DEEF-7FE3-9EF198F0E01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007" t="54944" r="65705"/>
          <a:stretch/>
        </p:blipFill>
        <p:spPr>
          <a:xfrm>
            <a:off x="390524" y="3222753"/>
            <a:ext cx="1800225" cy="1365885"/>
          </a:xfrm>
          <a:prstGeom prst="rect">
            <a:avLst/>
          </a:prstGeom>
        </p:spPr>
      </p:pic>
      <p:pic>
        <p:nvPicPr>
          <p:cNvPr id="9" name="Picture 8" descr="A collage of cells&#10;&#10;Description automatically generated">
            <a:extLst>
              <a:ext uri="{FF2B5EF4-FFF2-40B4-BE49-F238E27FC236}">
                <a16:creationId xmlns:a16="http://schemas.microsoft.com/office/drawing/2014/main" id="{A9F72462-7881-DEEF-7FE3-9EF198F0E01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2680" t="54944" r="27032"/>
          <a:stretch/>
        </p:blipFill>
        <p:spPr>
          <a:xfrm>
            <a:off x="390523" y="5158510"/>
            <a:ext cx="1800225" cy="136588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366EC06-B3B6-1DDA-1E99-70848F100C3A}"/>
              </a:ext>
            </a:extLst>
          </p:cNvPr>
          <p:cNvSpPr txBox="1"/>
          <p:nvPr/>
        </p:nvSpPr>
        <p:spPr>
          <a:xfrm>
            <a:off x="1050827" y="791200"/>
            <a:ext cx="4796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Moc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AC9FFC7-68D9-A0E7-BCF2-04852D8D1380}"/>
              </a:ext>
            </a:extLst>
          </p:cNvPr>
          <p:cNvSpPr txBox="1"/>
          <p:nvPr/>
        </p:nvSpPr>
        <p:spPr>
          <a:xfrm>
            <a:off x="2888630" y="819775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8mg/kg Cispla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58E8B5-7FB2-C9CE-4AC3-9CFE6F0D99DE}"/>
              </a:ext>
            </a:extLst>
          </p:cNvPr>
          <p:cNvSpPr txBox="1"/>
          <p:nvPr/>
        </p:nvSpPr>
        <p:spPr>
          <a:xfrm>
            <a:off x="5046072" y="81977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Combo</a:t>
            </a:r>
          </a:p>
        </p:txBody>
      </p:sp>
    </p:spTree>
    <p:extLst>
      <p:ext uri="{BB962C8B-B14F-4D97-AF65-F5344CB8AC3E}">
        <p14:creationId xmlns:p14="http://schemas.microsoft.com/office/powerpoint/2010/main" val="3129776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6637B4-2A10-C83C-2390-C63C847BB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ge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5869B9-D278-6FEE-AF88-42F4C27CC5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algn="just">
              <a:spcAft>
                <a:spcPts val="1000"/>
              </a:spcAft>
            </a:pPr>
            <a:r>
              <a:rPr lang="en-US" sz="1800" b="1" i="1" u="sng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lang="en-US" sz="1800" b="1" i="1" u="sng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6: H&amp;E Analysis Did Not Detect Gross Deferential Nephrotoxicity. 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</a:t>
            </a:r>
            <a:r>
              <a:rPr lang="en-US" sz="1800" i="1" u="sng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tein casts in collecting ducts.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Karyomegaly. </a:t>
            </a:r>
            <a:r>
              <a:rPr lang="en-US" sz="1800" b="1" i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800" i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cute tubular epithelial cell injury.</a:t>
            </a:r>
            <a:endParaRPr lang="en-US" sz="1800" i="1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2795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55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Lege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holas Wallace</dc:creator>
  <cp:lastModifiedBy>Nicholas Wallace</cp:lastModifiedBy>
  <cp:revision>13</cp:revision>
  <dcterms:created xsi:type="dcterms:W3CDTF">2026-03-31T21:32:41Z</dcterms:created>
  <dcterms:modified xsi:type="dcterms:W3CDTF">2026-03-31T22:00:50Z</dcterms:modified>
</cp:coreProperties>
</file>